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EDD098-621C-4862-8817-928CED8675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CF7D24-E0DA-4105-9B36-E715EEA343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CF4C4-9DB7-464D-AD76-BB60BDB951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344EF-CDDB-45C4-B3F1-DF2618F137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934CF1-64C8-4356-BBB1-C96CF8796F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5D669-01BB-4D54-976E-087A1C18AC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D643C-3BC1-4FE1-B030-CAA43CB9B6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317600-B373-45C4-B633-E95254EFA2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AAFDB-7392-44C9-A916-EBCB7130DC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AE466-3523-4A34-B0F4-F83776AA40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575F39-0535-4140-9F53-7626226744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FE7DAF-2178-4201-B168-F54F3CA3D7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C2AEE95-3932-4FC6-B996-FED1551D0754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A37C428-6B72-4CF0-99DC-04C97E8EC39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165240" y="264960"/>
            <a:ext cx="8978760" cy="26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50 CGCATCGG CGCATCGG CGGATCGG CGCATCGG CGGATCGG CGCATCGG CGCATCGG CGCGT NE1  (Type A) 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Intr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50 CGCATCGG CGCATCGG CGGATCGG CGCATCGG CGGATCGG CGCATCGG CG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------ --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CGT NE10 (Type 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50 CGCATCGG CGCATCGG CGGATCGG CGCATCGG CG------ -------- -------- --CGT CH1  (Type 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50 CGCATCGG CGCATCGG CGCATCGG CG------ -------- -------- -------- --CGT CH7  (Type 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50 CGCATCGG CGCATCGG CG------ -------- -------- -------- -------- --CGT ND8  (Type 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50 CGCATCGG CG------ -------- -------- -------- -------- -------- --CGT NE7  (Type F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50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CGCATCGG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CG------ -------- -------- -------- -------- -------- --CGT STD  (Referenc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904 ACATCCCTGGGG ACATCCCTGGGG ACATCCCTGGGG ACATCCC TTCGAC NE1  (Type 1= 3) 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Ex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904 ACATCCCTGGGG ACATCCCTGGGG ACATCCCT---- ------- -TCGAC NE10 (Type 2= 6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904 ACATCCCTGGGG ACATCCCT---- ------------ ------- -TCGAC CH1  (Type 3= 3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904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ACATCCCTGGGG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ACATCCCT---- ------------ ------- -TCGAC STD  (Referenc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7"/>
          <p:cNvSpPr/>
          <p:nvPr/>
        </p:nvSpPr>
        <p:spPr>
          <a:xfrm>
            <a:off x="380880" y="455760"/>
            <a:ext cx="8610840" cy="1360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8"/>
          <p:cNvSpPr/>
          <p:nvPr/>
        </p:nvSpPr>
        <p:spPr>
          <a:xfrm>
            <a:off x="380880" y="1816200"/>
            <a:ext cx="7391520" cy="927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0"/>
          <p:cNvSpPr/>
          <p:nvPr/>
        </p:nvSpPr>
        <p:spPr>
          <a:xfrm>
            <a:off x="241200" y="3247920"/>
            <a:ext cx="8902800" cy="143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117 TCGCTATCGCCA TCGCTATCGCCA TCGCTATCGCCA TCGCTATCGCCA TCGCTATCGCCA TCGCTATCTCCA TCA CH75 (Type A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117 TCGCTATCGCCA TCGCTATCGCCA TCGCTATCGCCA TCGCTATCGCCA TCGCTATC---- --------TCCA TCA CH1  (Type B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117 TCGCTATCGCCA TCGCTATCGCCA TCGCTATCGCCA TCGCTATC---- ------------ --------TCCA TCA STD  (Reference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117 TCGCTATCGCCA TCGCTATCGCCA TCGCTATCGCCA TCGCTATC---- ------------ --------TCCA TCA CH7  (Type C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117 TCGCTATCGCCA TCGCTATCGCCA TCGCTATC---- ------------ ------------ --------TCCA TCA R41  (Type D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117 TCGCTATCGCCA TCGCTATC---- ------------ ------------ ------------ --------TCCA TCA CH63 (Type E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117 </a:t>
            </a:r>
            <a:r>
              <a:rPr b="0" lang="en-US" sz="11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TCGCTATCGCCA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 TC---------- ------------ ------------ ------------ ------------ --A ND7  (Type F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1"/>
          <p:cNvSpPr/>
          <p:nvPr/>
        </p:nvSpPr>
        <p:spPr>
          <a:xfrm>
            <a:off x="457200" y="4952880"/>
            <a:ext cx="73152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: Tandem repeat variation in housekeeping genes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rom Plasmodium vivax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eld isolat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)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NA gyras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B)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ibosomal protein l34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ndem repeat unit is underlined. Dash (-) represents deleted nucleotid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2"/>
          <p:cNvSpPr/>
          <p:nvPr/>
        </p:nvSpPr>
        <p:spPr>
          <a:xfrm>
            <a:off x="355680" y="3440160"/>
            <a:ext cx="8712000" cy="1411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9"/>
          <p:cNvSpPr/>
          <p:nvPr/>
        </p:nvSpPr>
        <p:spPr>
          <a:xfrm>
            <a:off x="345240" y="3137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461880" y="152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7T06:49:37Z</dcterms:created>
  <dc:creator>Surendra Kumar  Prajapati</dc:creator>
  <dc:description/>
  <dc:language>en-US</dc:language>
  <cp:lastModifiedBy>Surendra Kumar  Prajapati</cp:lastModifiedBy>
  <dcterms:modified xsi:type="dcterms:W3CDTF">2013-08-21T06:59:27Z</dcterms:modified>
  <cp:revision>18</cp:revision>
  <dc:subject/>
  <dc:title>Slide 1</dc:title>
</cp:coreProperties>
</file>